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3D8181-0FF2-488B-828D-42B54C2A1D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C2852A-1FC4-4D09-ACF7-DAF89B82B6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154FB0-0424-4A07-92A1-C714D865BC3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FC8D2-F4D8-4C0D-BB77-46DA75C625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D1F2A-9400-4653-8743-8960937514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3FB28-FEFA-44CB-87C8-0984C07C00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CC8F2-AC9A-4294-AC1E-B20E71F860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40223C-BDB2-41DF-8E2C-46BDDA0CE8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6927B-E31F-44E6-9ADE-5CD07C4AD2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23D46B-6F11-4846-AB1C-B50C12C3FF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C3A11-6A45-4855-9AEC-A6C867C601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2D5E0-2EA0-4503-AAE1-2DD2514C6B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A3C57F-28A9-4809-A795-7A05B2140C4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2"/>
          <p:cNvGraphicFramePr/>
          <p:nvPr/>
        </p:nvGraphicFramePr>
        <p:xfrm>
          <a:off x="1981080" y="878040"/>
          <a:ext cx="5105520" cy="4581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981080" y="878040"/>
                    <a:ext cx="5105520" cy="4581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Box 5"/>
          <p:cNvSpPr/>
          <p:nvPr/>
        </p:nvSpPr>
        <p:spPr>
          <a:xfrm>
            <a:off x="976320" y="5708520"/>
            <a:ext cx="7162920" cy="49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Average Bt-Cry1Ab protein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triped ba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) in different parts of T</a:t>
            </a:r>
            <a:r>
              <a:rPr b="0" lang="en-US" sz="1200" spc="-1" strike="noStrike" baseline="-30000">
                <a:solidFill>
                  <a:srgbClr val="000000"/>
                </a:solidFill>
                <a:latin typeface="Times New Roman"/>
                <a:ea typeface="Calibri"/>
              </a:rPr>
              <a:t>0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transgenic tomato plant Ab25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Dr D V Amla</dc:creator>
  <dc:description/>
  <dc:language>en-US</dc:language>
  <cp:lastModifiedBy> </cp:lastModifiedBy>
  <dcterms:modified xsi:type="dcterms:W3CDTF">2014-01-28T12:45:48Z</dcterms:modified>
  <cp:revision>8</cp:revision>
  <dc:subject/>
  <dc:title>Slide 1</dc:title>
</cp:coreProperties>
</file>